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C2A69-CF39-472D-B128-CF58B9A1F3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D2843-6545-4D04-9A8C-A3B0220E3B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AFB8A-224F-46D4-8E5A-0306665DBF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74CD2-2BC8-4082-94FD-13E3591E35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A05A4-9BE7-4763-9ED7-D23638A34A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33505-A9A7-441C-910B-FD8E1F3C47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23038-BB25-4FC5-9D87-915D3A4C3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BEAB5C-BCC4-453B-A2F8-292EB810B7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928050-B1B7-4AD2-BACE-CEE7C35718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519CC-94BD-4CBF-9D10-94222AE4FA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3E9EB-B890-496C-8D82-A777D00EE7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2689D-A54D-4AD8-9EE8-083BF550F8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750859-A67D-4BA1-93E1-3F23421ABBD4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611280" y="4371120"/>
            <a:ext cx="5832360" cy="110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52280" bIns="3816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- Effect of BRE supplementation on mRNA levels of SREBP-1 in liver of mice that were fed different diet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are expressed as mean ± standard error (n=8 for each group). not significant by ANOVA at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0.05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3" name="Object 4"/>
          <p:cNvGraphicFramePr/>
          <p:nvPr/>
        </p:nvGraphicFramePr>
        <p:xfrm>
          <a:off x="611280" y="333360"/>
          <a:ext cx="5352840" cy="41432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1280" y="333360"/>
                    <a:ext cx="5352840" cy="414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4T00:44:25Z</dcterms:created>
  <dc:creator>Your User Name</dc:creator>
  <dc:description/>
  <dc:language>en-US</dc:language>
  <cp:lastModifiedBy>Your User Name</cp:lastModifiedBy>
  <dcterms:modified xsi:type="dcterms:W3CDTF">2012-03-08T11:00:02Z</dcterms:modified>
  <cp:revision>43</cp:revision>
  <dc:subject/>
  <dc:title>슬라이드 1</dc:title>
</cp:coreProperties>
</file>